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256" r:id="rId2"/>
    <p:sldId id="272" r:id="rId3"/>
    <p:sldId id="273" r:id="rId4"/>
  </p:sldIdLst>
  <p:sldSz cx="6173788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0573159-EA8F-194D-BBDC-FBED364F5016}" v="30" dt="2024-06-23T01:11:15.36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300"/>
    <p:restoredTop sz="96190"/>
  </p:normalViewPr>
  <p:slideViewPr>
    <p:cSldViewPr snapToGrid="0">
      <p:cViewPr>
        <p:scale>
          <a:sx n="200" d="100"/>
          <a:sy n="200" d="100"/>
        </p:scale>
        <p:origin x="57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F05622-AC9E-8C4D-B08A-D110B02BF56E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466975" y="1143000"/>
            <a:ext cx="1924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3E644D-C552-BD4B-A780-8E778966F3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91952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3E644D-C552-BD4B-A780-8E778966F3EA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03182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3E644D-C552-BD4B-A780-8E778966F3EA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13192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3034" y="1621191"/>
            <a:ext cx="5247720" cy="3448756"/>
          </a:xfrm>
        </p:spPr>
        <p:txBody>
          <a:bodyPr anchor="b"/>
          <a:lstStyle>
            <a:lvl1pPr algn="ctr">
              <a:defRPr sz="405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1724" y="5202944"/>
            <a:ext cx="4630341" cy="2391656"/>
          </a:xfrm>
        </p:spPr>
        <p:txBody>
          <a:bodyPr/>
          <a:lstStyle>
            <a:lvl1pPr marL="0" indent="0" algn="ctr">
              <a:buNone/>
              <a:defRPr sz="1620"/>
            </a:lvl1pPr>
            <a:lvl2pPr marL="308701" indent="0" algn="ctr">
              <a:buNone/>
              <a:defRPr sz="1350"/>
            </a:lvl2pPr>
            <a:lvl3pPr marL="617403" indent="0" algn="ctr">
              <a:buNone/>
              <a:defRPr sz="1215"/>
            </a:lvl3pPr>
            <a:lvl4pPr marL="926104" indent="0" algn="ctr">
              <a:buNone/>
              <a:defRPr sz="1080"/>
            </a:lvl4pPr>
            <a:lvl5pPr marL="1234806" indent="0" algn="ctr">
              <a:buNone/>
              <a:defRPr sz="1080"/>
            </a:lvl5pPr>
            <a:lvl6pPr marL="1543507" indent="0" algn="ctr">
              <a:buNone/>
              <a:defRPr sz="1080"/>
            </a:lvl6pPr>
            <a:lvl7pPr marL="1852209" indent="0" algn="ctr">
              <a:buNone/>
              <a:defRPr sz="1080"/>
            </a:lvl7pPr>
            <a:lvl8pPr marL="2160910" indent="0" algn="ctr">
              <a:buNone/>
              <a:defRPr sz="1080"/>
            </a:lvl8pPr>
            <a:lvl9pPr marL="2469612" indent="0" algn="ctr">
              <a:buNone/>
              <a:defRPr sz="10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3274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023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18117" y="527403"/>
            <a:ext cx="1331223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4448" y="527403"/>
            <a:ext cx="3916497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41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1071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233" y="2469624"/>
            <a:ext cx="5324892" cy="4120620"/>
          </a:xfrm>
        </p:spPr>
        <p:txBody>
          <a:bodyPr anchor="b"/>
          <a:lstStyle>
            <a:lvl1pPr>
              <a:defRPr sz="405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233" y="6629226"/>
            <a:ext cx="5324892" cy="2166937"/>
          </a:xfrm>
        </p:spPr>
        <p:txBody>
          <a:bodyPr/>
          <a:lstStyle>
            <a:lvl1pPr marL="0" indent="0">
              <a:buNone/>
              <a:defRPr sz="1620">
                <a:solidFill>
                  <a:schemeClr val="tx1"/>
                </a:solidFill>
              </a:defRPr>
            </a:lvl1pPr>
            <a:lvl2pPr marL="308701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17403" indent="0">
              <a:buNone/>
              <a:defRPr sz="1215">
                <a:solidFill>
                  <a:schemeClr val="tx1">
                    <a:tint val="75000"/>
                  </a:schemeClr>
                </a:solidFill>
              </a:defRPr>
            </a:lvl3pPr>
            <a:lvl4pPr marL="926104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4pPr>
            <a:lvl5pPr marL="1234806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5pPr>
            <a:lvl6pPr marL="1543507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6pPr>
            <a:lvl7pPr marL="1852209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7pPr>
            <a:lvl8pPr marL="216091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8pPr>
            <a:lvl9pPr marL="2469612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317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4448" y="2637014"/>
            <a:ext cx="262386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25480" y="2637014"/>
            <a:ext cx="262386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8059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5252" y="527405"/>
            <a:ext cx="5324892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5253" y="2428347"/>
            <a:ext cx="2611801" cy="1190095"/>
          </a:xfrm>
        </p:spPr>
        <p:txBody>
          <a:bodyPr anchor="b"/>
          <a:lstStyle>
            <a:lvl1pPr marL="0" indent="0">
              <a:buNone/>
              <a:defRPr sz="1620" b="1"/>
            </a:lvl1pPr>
            <a:lvl2pPr marL="308701" indent="0">
              <a:buNone/>
              <a:defRPr sz="1350" b="1"/>
            </a:lvl2pPr>
            <a:lvl3pPr marL="617403" indent="0">
              <a:buNone/>
              <a:defRPr sz="1215" b="1"/>
            </a:lvl3pPr>
            <a:lvl4pPr marL="926104" indent="0">
              <a:buNone/>
              <a:defRPr sz="1080" b="1"/>
            </a:lvl4pPr>
            <a:lvl5pPr marL="1234806" indent="0">
              <a:buNone/>
              <a:defRPr sz="1080" b="1"/>
            </a:lvl5pPr>
            <a:lvl6pPr marL="1543507" indent="0">
              <a:buNone/>
              <a:defRPr sz="1080" b="1"/>
            </a:lvl6pPr>
            <a:lvl7pPr marL="1852209" indent="0">
              <a:buNone/>
              <a:defRPr sz="1080" b="1"/>
            </a:lvl7pPr>
            <a:lvl8pPr marL="2160910" indent="0">
              <a:buNone/>
              <a:defRPr sz="1080" b="1"/>
            </a:lvl8pPr>
            <a:lvl9pPr marL="2469612" indent="0">
              <a:buNone/>
              <a:defRPr sz="10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5253" y="3618442"/>
            <a:ext cx="2611801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25481" y="2428347"/>
            <a:ext cx="2624664" cy="1190095"/>
          </a:xfrm>
        </p:spPr>
        <p:txBody>
          <a:bodyPr anchor="b"/>
          <a:lstStyle>
            <a:lvl1pPr marL="0" indent="0">
              <a:buNone/>
              <a:defRPr sz="1620" b="1"/>
            </a:lvl1pPr>
            <a:lvl2pPr marL="308701" indent="0">
              <a:buNone/>
              <a:defRPr sz="1350" b="1"/>
            </a:lvl2pPr>
            <a:lvl3pPr marL="617403" indent="0">
              <a:buNone/>
              <a:defRPr sz="1215" b="1"/>
            </a:lvl3pPr>
            <a:lvl4pPr marL="926104" indent="0">
              <a:buNone/>
              <a:defRPr sz="1080" b="1"/>
            </a:lvl4pPr>
            <a:lvl5pPr marL="1234806" indent="0">
              <a:buNone/>
              <a:defRPr sz="1080" b="1"/>
            </a:lvl5pPr>
            <a:lvl6pPr marL="1543507" indent="0">
              <a:buNone/>
              <a:defRPr sz="1080" b="1"/>
            </a:lvl6pPr>
            <a:lvl7pPr marL="1852209" indent="0">
              <a:buNone/>
              <a:defRPr sz="1080" b="1"/>
            </a:lvl7pPr>
            <a:lvl8pPr marL="2160910" indent="0">
              <a:buNone/>
              <a:defRPr sz="1080" b="1"/>
            </a:lvl8pPr>
            <a:lvl9pPr marL="2469612" indent="0">
              <a:buNone/>
              <a:defRPr sz="10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25481" y="3618442"/>
            <a:ext cx="2624664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5026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1610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4900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5252" y="660400"/>
            <a:ext cx="1991207" cy="2311400"/>
          </a:xfrm>
        </p:spPr>
        <p:txBody>
          <a:bodyPr anchor="b"/>
          <a:lstStyle>
            <a:lvl1pPr>
              <a:defRPr sz="216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24664" y="1426283"/>
            <a:ext cx="3125480" cy="7039681"/>
          </a:xfrm>
        </p:spPr>
        <p:txBody>
          <a:bodyPr/>
          <a:lstStyle>
            <a:lvl1pPr>
              <a:defRPr sz="2161"/>
            </a:lvl1pPr>
            <a:lvl2pPr>
              <a:defRPr sz="1891"/>
            </a:lvl2pPr>
            <a:lvl3pPr>
              <a:defRPr sz="162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5252" y="2971800"/>
            <a:ext cx="1991207" cy="5505627"/>
          </a:xfrm>
        </p:spPr>
        <p:txBody>
          <a:bodyPr/>
          <a:lstStyle>
            <a:lvl1pPr marL="0" indent="0">
              <a:buNone/>
              <a:defRPr sz="1080"/>
            </a:lvl1pPr>
            <a:lvl2pPr marL="308701" indent="0">
              <a:buNone/>
              <a:defRPr sz="945"/>
            </a:lvl2pPr>
            <a:lvl3pPr marL="617403" indent="0">
              <a:buNone/>
              <a:defRPr sz="810"/>
            </a:lvl3pPr>
            <a:lvl4pPr marL="926104" indent="0">
              <a:buNone/>
              <a:defRPr sz="675"/>
            </a:lvl4pPr>
            <a:lvl5pPr marL="1234806" indent="0">
              <a:buNone/>
              <a:defRPr sz="675"/>
            </a:lvl5pPr>
            <a:lvl6pPr marL="1543507" indent="0">
              <a:buNone/>
              <a:defRPr sz="675"/>
            </a:lvl6pPr>
            <a:lvl7pPr marL="1852209" indent="0">
              <a:buNone/>
              <a:defRPr sz="675"/>
            </a:lvl7pPr>
            <a:lvl8pPr marL="2160910" indent="0">
              <a:buNone/>
              <a:defRPr sz="675"/>
            </a:lvl8pPr>
            <a:lvl9pPr marL="2469612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0491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5252" y="660400"/>
            <a:ext cx="1991207" cy="2311400"/>
          </a:xfrm>
        </p:spPr>
        <p:txBody>
          <a:bodyPr anchor="b"/>
          <a:lstStyle>
            <a:lvl1pPr>
              <a:defRPr sz="216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24664" y="1426283"/>
            <a:ext cx="3125480" cy="7039681"/>
          </a:xfrm>
        </p:spPr>
        <p:txBody>
          <a:bodyPr anchor="t"/>
          <a:lstStyle>
            <a:lvl1pPr marL="0" indent="0">
              <a:buNone/>
              <a:defRPr sz="2161"/>
            </a:lvl1pPr>
            <a:lvl2pPr marL="308701" indent="0">
              <a:buNone/>
              <a:defRPr sz="1891"/>
            </a:lvl2pPr>
            <a:lvl3pPr marL="617403" indent="0">
              <a:buNone/>
              <a:defRPr sz="1620"/>
            </a:lvl3pPr>
            <a:lvl4pPr marL="926104" indent="0">
              <a:buNone/>
              <a:defRPr sz="1350"/>
            </a:lvl4pPr>
            <a:lvl5pPr marL="1234806" indent="0">
              <a:buNone/>
              <a:defRPr sz="1350"/>
            </a:lvl5pPr>
            <a:lvl6pPr marL="1543507" indent="0">
              <a:buNone/>
              <a:defRPr sz="1350"/>
            </a:lvl6pPr>
            <a:lvl7pPr marL="1852209" indent="0">
              <a:buNone/>
              <a:defRPr sz="1350"/>
            </a:lvl7pPr>
            <a:lvl8pPr marL="2160910" indent="0">
              <a:buNone/>
              <a:defRPr sz="1350"/>
            </a:lvl8pPr>
            <a:lvl9pPr marL="2469612" indent="0">
              <a:buNone/>
              <a:defRPr sz="135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5252" y="2971800"/>
            <a:ext cx="1991207" cy="5505627"/>
          </a:xfrm>
        </p:spPr>
        <p:txBody>
          <a:bodyPr/>
          <a:lstStyle>
            <a:lvl1pPr marL="0" indent="0">
              <a:buNone/>
              <a:defRPr sz="1080"/>
            </a:lvl1pPr>
            <a:lvl2pPr marL="308701" indent="0">
              <a:buNone/>
              <a:defRPr sz="945"/>
            </a:lvl2pPr>
            <a:lvl3pPr marL="617403" indent="0">
              <a:buNone/>
              <a:defRPr sz="810"/>
            </a:lvl3pPr>
            <a:lvl4pPr marL="926104" indent="0">
              <a:buNone/>
              <a:defRPr sz="675"/>
            </a:lvl4pPr>
            <a:lvl5pPr marL="1234806" indent="0">
              <a:buNone/>
              <a:defRPr sz="675"/>
            </a:lvl5pPr>
            <a:lvl6pPr marL="1543507" indent="0">
              <a:buNone/>
              <a:defRPr sz="675"/>
            </a:lvl6pPr>
            <a:lvl7pPr marL="1852209" indent="0">
              <a:buNone/>
              <a:defRPr sz="675"/>
            </a:lvl7pPr>
            <a:lvl8pPr marL="2160910" indent="0">
              <a:buNone/>
              <a:defRPr sz="675"/>
            </a:lvl8pPr>
            <a:lvl9pPr marL="2469612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0036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4448" y="527405"/>
            <a:ext cx="5324892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448" y="2637014"/>
            <a:ext cx="5324892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4448" y="9181397"/>
            <a:ext cx="138910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354EF-A093-2643-9DEC-2C86F4440660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45068" y="9181397"/>
            <a:ext cx="2083653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60238" y="9181397"/>
            <a:ext cx="138910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D1994-B50D-6B48-8064-AC27527E90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7882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17403" rtl="0" eaLnBrk="1" latinLnBrk="0" hangingPunct="1">
        <a:lnSpc>
          <a:spcPct val="90000"/>
        </a:lnSpc>
        <a:spcBef>
          <a:spcPct val="0"/>
        </a:spcBef>
        <a:buNone/>
        <a:defRPr kumimoji="1" sz="297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4351" indent="-154351" algn="l" defTabSz="617403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kumimoji="1" sz="1891" kern="1200">
          <a:solidFill>
            <a:schemeClr val="tx1"/>
          </a:solidFill>
          <a:latin typeface="+mn-lt"/>
          <a:ea typeface="+mn-ea"/>
          <a:cs typeface="+mn-cs"/>
        </a:defRPr>
      </a:lvl1pPr>
      <a:lvl2pPr marL="463052" indent="-154351" algn="l" defTabSz="617403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kumimoji="1"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771754" indent="-154351" algn="l" defTabSz="617403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80455" indent="-154351" algn="l" defTabSz="617403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4pPr>
      <a:lvl5pPr marL="1389156" indent="-154351" algn="l" defTabSz="617403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5pPr>
      <a:lvl6pPr marL="1697858" indent="-154351" algn="l" defTabSz="617403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6pPr>
      <a:lvl7pPr marL="2006559" indent="-154351" algn="l" defTabSz="617403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7pPr>
      <a:lvl8pPr marL="2315261" indent="-154351" algn="l" defTabSz="617403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8pPr>
      <a:lvl9pPr marL="2623962" indent="-154351" algn="l" defTabSz="617403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7403" rtl="0" eaLnBrk="1" latinLnBrk="0" hangingPunct="1"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1pPr>
      <a:lvl2pPr marL="308701" algn="l" defTabSz="617403" rtl="0" eaLnBrk="1" latinLnBrk="0" hangingPunct="1"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2pPr>
      <a:lvl3pPr marL="617403" algn="l" defTabSz="617403" rtl="0" eaLnBrk="1" latinLnBrk="0" hangingPunct="1"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3pPr>
      <a:lvl4pPr marL="926104" algn="l" defTabSz="617403" rtl="0" eaLnBrk="1" latinLnBrk="0" hangingPunct="1"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4pPr>
      <a:lvl5pPr marL="1234806" algn="l" defTabSz="617403" rtl="0" eaLnBrk="1" latinLnBrk="0" hangingPunct="1"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5pPr>
      <a:lvl6pPr marL="1543507" algn="l" defTabSz="617403" rtl="0" eaLnBrk="1" latinLnBrk="0" hangingPunct="1"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6pPr>
      <a:lvl7pPr marL="1852209" algn="l" defTabSz="617403" rtl="0" eaLnBrk="1" latinLnBrk="0" hangingPunct="1"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7pPr>
      <a:lvl8pPr marL="2160910" algn="l" defTabSz="617403" rtl="0" eaLnBrk="1" latinLnBrk="0" hangingPunct="1"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8pPr>
      <a:lvl9pPr marL="2469612" algn="l" defTabSz="617403" rtl="0" eaLnBrk="1" latinLnBrk="0" hangingPunct="1">
        <a:defRPr kumimoji="1" sz="12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11" Type="http://schemas.openxmlformats.org/officeDocument/2006/relationships/image" Target="../media/image18.emf"/><Relationship Id="rId5" Type="http://schemas.openxmlformats.org/officeDocument/2006/relationships/image" Target="../media/image12.emf"/><Relationship Id="rId10" Type="http://schemas.openxmlformats.org/officeDocument/2006/relationships/image" Target="../media/image17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3A649A-D644-AB74-0045-CA46B15C17C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ja-JP" sz="2160" dirty="0">
                <a:latin typeface="Arial" panose="020B0604020202020204" pitchFamily="34" charset="0"/>
                <a:cs typeface="Arial" panose="020B0604020202020204" pitchFamily="34" charset="0"/>
              </a:rPr>
              <a:t>Fractal dimension, circularity, and solidity of cell clusters in liquid-based endometrial cytology are potentially useful for endometrial cancer detection and prognosis prediction</a:t>
            </a:r>
            <a:endParaRPr lang="ja-JP" altLang="en-US" sz="216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4824A29-15F3-AC16-C70F-9931A80EBC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71724" y="5632170"/>
            <a:ext cx="4630341" cy="335378"/>
          </a:xfrm>
        </p:spPr>
        <p:txBody>
          <a:bodyPr/>
          <a:lstStyle/>
          <a:p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Toshimichi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Onum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98F9FB4-A334-3B32-983B-F1B831177ADC}"/>
              </a:ext>
            </a:extLst>
          </p:cNvPr>
          <p:cNvSpPr txBox="1"/>
          <p:nvPr/>
        </p:nvSpPr>
        <p:spPr>
          <a:xfrm>
            <a:off x="1617959" y="2408706"/>
            <a:ext cx="2937871" cy="42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160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endParaRPr kumimoji="1" lang="ja-JP" altLang="en-US" sz="216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3242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893A45C-47C4-5561-2E3A-E8A80FA439EB}"/>
              </a:ext>
            </a:extLst>
          </p:cNvPr>
          <p:cNvSpPr txBox="1"/>
          <p:nvPr/>
        </p:nvSpPr>
        <p:spPr>
          <a:xfrm flipH="1">
            <a:off x="9068" y="438199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568F46F-294F-2F81-B0FA-209DEC1AAD3C}"/>
              </a:ext>
            </a:extLst>
          </p:cNvPr>
          <p:cNvSpPr txBox="1"/>
          <p:nvPr/>
        </p:nvSpPr>
        <p:spPr>
          <a:xfrm flipH="1">
            <a:off x="2068028" y="438199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A714B67-BB86-AD35-19AA-1B58F90D01C4}"/>
              </a:ext>
            </a:extLst>
          </p:cNvPr>
          <p:cNvSpPr txBox="1"/>
          <p:nvPr/>
        </p:nvSpPr>
        <p:spPr>
          <a:xfrm flipH="1">
            <a:off x="4126987" y="438199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1E301EC-A865-2E5F-1885-E6C630B7B6AD}"/>
              </a:ext>
            </a:extLst>
          </p:cNvPr>
          <p:cNvSpPr txBox="1"/>
          <p:nvPr/>
        </p:nvSpPr>
        <p:spPr>
          <a:xfrm>
            <a:off x="304517" y="529051"/>
            <a:ext cx="1729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erimeter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A4202CB-1787-F458-97FA-20D2ECC33362}"/>
              </a:ext>
            </a:extLst>
          </p:cNvPr>
          <p:cNvSpPr txBox="1"/>
          <p:nvPr/>
        </p:nvSpPr>
        <p:spPr>
          <a:xfrm flipH="1">
            <a:off x="9068" y="2799333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0FE02C2-022D-B8DD-350E-C4EFEAE7CD0A}"/>
              </a:ext>
            </a:extLst>
          </p:cNvPr>
          <p:cNvSpPr txBox="1"/>
          <p:nvPr/>
        </p:nvSpPr>
        <p:spPr>
          <a:xfrm flipH="1">
            <a:off x="2068028" y="2799333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B03789E-7645-119E-46F9-BE4B814E7804}"/>
              </a:ext>
            </a:extLst>
          </p:cNvPr>
          <p:cNvSpPr txBox="1"/>
          <p:nvPr/>
        </p:nvSpPr>
        <p:spPr>
          <a:xfrm flipH="1">
            <a:off x="4126987" y="2799333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4586777-84B1-9FE9-2305-64C4D63F9933}"/>
              </a:ext>
            </a:extLst>
          </p:cNvPr>
          <p:cNvSpPr txBox="1"/>
          <p:nvPr/>
        </p:nvSpPr>
        <p:spPr>
          <a:xfrm>
            <a:off x="2365206" y="529051"/>
            <a:ext cx="17625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it ellipse Major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CE3A68A-236A-C465-0C77-57552156E534}"/>
              </a:ext>
            </a:extLst>
          </p:cNvPr>
          <p:cNvSpPr txBox="1"/>
          <p:nvPr/>
        </p:nvSpPr>
        <p:spPr>
          <a:xfrm>
            <a:off x="4328864" y="529051"/>
            <a:ext cx="18202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it ellipse Minor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AC3A269-190A-9598-7BEB-23424F0D7091}"/>
              </a:ext>
            </a:extLst>
          </p:cNvPr>
          <p:cNvSpPr txBox="1"/>
          <p:nvPr/>
        </p:nvSpPr>
        <p:spPr>
          <a:xfrm flipH="1">
            <a:off x="9068" y="5160467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E2C4DA-08C8-67E6-E4FB-8A6A5C8240E2}"/>
              </a:ext>
            </a:extLst>
          </p:cNvPr>
          <p:cNvSpPr txBox="1"/>
          <p:nvPr/>
        </p:nvSpPr>
        <p:spPr>
          <a:xfrm>
            <a:off x="279978" y="2916976"/>
            <a:ext cx="1800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ngle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A9DA573-BDA3-AB41-0DC6-5B04A5B6F001}"/>
              </a:ext>
            </a:extLst>
          </p:cNvPr>
          <p:cNvSpPr txBox="1"/>
          <p:nvPr/>
        </p:nvSpPr>
        <p:spPr>
          <a:xfrm>
            <a:off x="2422443" y="2916976"/>
            <a:ext cx="1736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ircularity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23A304F-20CA-DBD1-5707-33C5B404EBBD}"/>
              </a:ext>
            </a:extLst>
          </p:cNvPr>
          <p:cNvSpPr txBox="1"/>
          <p:nvPr/>
        </p:nvSpPr>
        <p:spPr>
          <a:xfrm flipH="1">
            <a:off x="2068028" y="5160467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A1FE8E2-3D87-AD77-7BCB-04AB1A36009C}"/>
              </a:ext>
            </a:extLst>
          </p:cNvPr>
          <p:cNvSpPr txBox="1"/>
          <p:nvPr/>
        </p:nvSpPr>
        <p:spPr>
          <a:xfrm flipH="1">
            <a:off x="4126987" y="5160467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2EA90EE-DD44-AEDA-313E-FA7A4B783DC4}"/>
              </a:ext>
            </a:extLst>
          </p:cNvPr>
          <p:cNvSpPr txBox="1"/>
          <p:nvPr/>
        </p:nvSpPr>
        <p:spPr>
          <a:xfrm>
            <a:off x="269180" y="5287362"/>
            <a:ext cx="1729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 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Feret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diameter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3CC1D42-1F39-0E99-B7AE-90E49E328F5B}"/>
              </a:ext>
            </a:extLst>
          </p:cNvPr>
          <p:cNvSpPr txBox="1"/>
          <p:nvPr/>
        </p:nvSpPr>
        <p:spPr>
          <a:xfrm>
            <a:off x="4370470" y="2947908"/>
            <a:ext cx="1736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 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Feret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diameter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12CF4EC-060D-1E67-484A-4BF2BD5AFC2E}"/>
              </a:ext>
            </a:extLst>
          </p:cNvPr>
          <p:cNvSpPr txBox="1"/>
          <p:nvPr/>
        </p:nvSpPr>
        <p:spPr>
          <a:xfrm>
            <a:off x="2386602" y="5287362"/>
            <a:ext cx="17625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idity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2D338A4-FC81-B263-062F-EDA40ADD857D}"/>
              </a:ext>
            </a:extLst>
          </p:cNvPr>
          <p:cNvSpPr txBox="1"/>
          <p:nvPr/>
        </p:nvSpPr>
        <p:spPr>
          <a:xfrm>
            <a:off x="4353533" y="5287362"/>
            <a:ext cx="18202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ractal dimension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63D08E3-925A-9AAD-246A-B8CB7D1E4748}"/>
              </a:ext>
            </a:extLst>
          </p:cNvPr>
          <p:cNvSpPr txBox="1"/>
          <p:nvPr/>
        </p:nvSpPr>
        <p:spPr>
          <a:xfrm>
            <a:off x="0" y="95860"/>
            <a:ext cx="5788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igure S1 Relationship between thresholds and sensitivity or specificity in ROC analysis for all age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図 31">
            <a:extLst>
              <a:ext uri="{FF2B5EF4-FFF2-40B4-BE49-F238E27FC236}">
                <a16:creationId xmlns:a16="http://schemas.microsoft.com/office/drawing/2014/main" id="{23E62306-7B30-7CA1-6CF3-5787C32054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108" y="599827"/>
            <a:ext cx="2088000" cy="2088000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4658DBB9-EAFD-2BDF-A6F2-B784F1466AE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39611" y="599827"/>
            <a:ext cx="2088000" cy="2088000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46E10F33-D5EA-B4CA-09EE-0086C6BDB75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26987" y="599827"/>
            <a:ext cx="2088000" cy="2088000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F9F5CAFE-4F3D-853D-4A2E-F80A5906142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108" y="3088672"/>
            <a:ext cx="2088000" cy="2088000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577A5952-A364-E7A1-A0B5-DC4C005008C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39611" y="3088672"/>
            <a:ext cx="2088000" cy="2088000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38FB51BB-44EF-F6C4-024E-DBB03C4DBD5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26987" y="3088672"/>
            <a:ext cx="2088000" cy="2088000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2C322E4D-7E1D-8006-323B-9CE927DBBE3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7108" y="5283577"/>
            <a:ext cx="2088000" cy="2088000"/>
          </a:xfrm>
          <a:prstGeom prst="rect">
            <a:avLst/>
          </a:prstGeom>
        </p:spPr>
      </p:pic>
      <p:pic>
        <p:nvPicPr>
          <p:cNvPr id="49" name="図 48">
            <a:extLst>
              <a:ext uri="{FF2B5EF4-FFF2-40B4-BE49-F238E27FC236}">
                <a16:creationId xmlns:a16="http://schemas.microsoft.com/office/drawing/2014/main" id="{7526D91E-09F1-DCBB-2930-EE9FAD7CF56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39611" y="5283577"/>
            <a:ext cx="2088000" cy="2088000"/>
          </a:xfrm>
          <a:prstGeom prst="rect">
            <a:avLst/>
          </a:prstGeom>
        </p:spPr>
      </p:pic>
      <p:pic>
        <p:nvPicPr>
          <p:cNvPr id="53" name="図 52">
            <a:extLst>
              <a:ext uri="{FF2B5EF4-FFF2-40B4-BE49-F238E27FC236}">
                <a16:creationId xmlns:a16="http://schemas.microsoft.com/office/drawing/2014/main" id="{EEF0FAA0-9899-D197-ED13-88468CDDD87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26987" y="5283577"/>
            <a:ext cx="2088000" cy="208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92742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893A45C-47C4-5561-2E3A-E8A80FA439EB}"/>
              </a:ext>
            </a:extLst>
          </p:cNvPr>
          <p:cNvSpPr txBox="1"/>
          <p:nvPr/>
        </p:nvSpPr>
        <p:spPr>
          <a:xfrm flipH="1">
            <a:off x="9068" y="438199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568F46F-294F-2F81-B0FA-209DEC1AAD3C}"/>
              </a:ext>
            </a:extLst>
          </p:cNvPr>
          <p:cNvSpPr txBox="1"/>
          <p:nvPr/>
        </p:nvSpPr>
        <p:spPr>
          <a:xfrm flipH="1">
            <a:off x="2068028" y="438199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A714B67-BB86-AD35-19AA-1B58F90D01C4}"/>
              </a:ext>
            </a:extLst>
          </p:cNvPr>
          <p:cNvSpPr txBox="1"/>
          <p:nvPr/>
        </p:nvSpPr>
        <p:spPr>
          <a:xfrm flipH="1">
            <a:off x="4126987" y="438199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1E301EC-A865-2E5F-1885-E6C630B7B6AD}"/>
              </a:ext>
            </a:extLst>
          </p:cNvPr>
          <p:cNvSpPr txBox="1"/>
          <p:nvPr/>
        </p:nvSpPr>
        <p:spPr>
          <a:xfrm>
            <a:off x="304517" y="529051"/>
            <a:ext cx="1729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erimeter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A4202CB-1787-F458-97FA-20D2ECC33362}"/>
              </a:ext>
            </a:extLst>
          </p:cNvPr>
          <p:cNvSpPr txBox="1"/>
          <p:nvPr/>
        </p:nvSpPr>
        <p:spPr>
          <a:xfrm flipH="1">
            <a:off x="9068" y="2799333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0FE02C2-022D-B8DD-350E-C4EFEAE7CD0A}"/>
              </a:ext>
            </a:extLst>
          </p:cNvPr>
          <p:cNvSpPr txBox="1"/>
          <p:nvPr/>
        </p:nvSpPr>
        <p:spPr>
          <a:xfrm flipH="1">
            <a:off x="2068028" y="2799333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B03789E-7645-119E-46F9-BE4B814E7804}"/>
              </a:ext>
            </a:extLst>
          </p:cNvPr>
          <p:cNvSpPr txBox="1"/>
          <p:nvPr/>
        </p:nvSpPr>
        <p:spPr>
          <a:xfrm flipH="1">
            <a:off x="4126987" y="2799333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4586777-84B1-9FE9-2305-64C4D63F9933}"/>
              </a:ext>
            </a:extLst>
          </p:cNvPr>
          <p:cNvSpPr txBox="1"/>
          <p:nvPr/>
        </p:nvSpPr>
        <p:spPr>
          <a:xfrm>
            <a:off x="2365206" y="529051"/>
            <a:ext cx="17625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it ellipse Major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CE3A68A-236A-C465-0C77-57552156E534}"/>
              </a:ext>
            </a:extLst>
          </p:cNvPr>
          <p:cNvSpPr txBox="1"/>
          <p:nvPr/>
        </p:nvSpPr>
        <p:spPr>
          <a:xfrm>
            <a:off x="4328864" y="529051"/>
            <a:ext cx="18202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it ellipse Minor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AC3A269-190A-9598-7BEB-23424F0D7091}"/>
              </a:ext>
            </a:extLst>
          </p:cNvPr>
          <p:cNvSpPr txBox="1"/>
          <p:nvPr/>
        </p:nvSpPr>
        <p:spPr>
          <a:xfrm flipH="1">
            <a:off x="9068" y="5160467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E2C4DA-08C8-67E6-E4FB-8A6A5C8240E2}"/>
              </a:ext>
            </a:extLst>
          </p:cNvPr>
          <p:cNvSpPr txBox="1"/>
          <p:nvPr/>
        </p:nvSpPr>
        <p:spPr>
          <a:xfrm>
            <a:off x="279978" y="2916976"/>
            <a:ext cx="1800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ngle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A9DA573-BDA3-AB41-0DC6-5B04A5B6F001}"/>
              </a:ext>
            </a:extLst>
          </p:cNvPr>
          <p:cNvSpPr txBox="1"/>
          <p:nvPr/>
        </p:nvSpPr>
        <p:spPr>
          <a:xfrm>
            <a:off x="2422443" y="2916976"/>
            <a:ext cx="1736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ircularity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23A304F-20CA-DBD1-5707-33C5B404EBBD}"/>
              </a:ext>
            </a:extLst>
          </p:cNvPr>
          <p:cNvSpPr txBox="1"/>
          <p:nvPr/>
        </p:nvSpPr>
        <p:spPr>
          <a:xfrm flipH="1">
            <a:off x="2068028" y="5160467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A1FE8E2-3D87-AD77-7BCB-04AB1A36009C}"/>
              </a:ext>
            </a:extLst>
          </p:cNvPr>
          <p:cNvSpPr txBox="1"/>
          <p:nvPr/>
        </p:nvSpPr>
        <p:spPr>
          <a:xfrm flipH="1">
            <a:off x="4126987" y="5160467"/>
            <a:ext cx="20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2EA90EE-DD44-AEDA-313E-FA7A4B783DC4}"/>
              </a:ext>
            </a:extLst>
          </p:cNvPr>
          <p:cNvSpPr txBox="1"/>
          <p:nvPr/>
        </p:nvSpPr>
        <p:spPr>
          <a:xfrm>
            <a:off x="269180" y="5287362"/>
            <a:ext cx="1729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 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Feret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diameter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3CC1D42-1F39-0E99-B7AE-90E49E328F5B}"/>
              </a:ext>
            </a:extLst>
          </p:cNvPr>
          <p:cNvSpPr txBox="1"/>
          <p:nvPr/>
        </p:nvSpPr>
        <p:spPr>
          <a:xfrm>
            <a:off x="4370470" y="2947908"/>
            <a:ext cx="1736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 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Feret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diameter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12CF4EC-060D-1E67-484A-4BF2BD5AFC2E}"/>
              </a:ext>
            </a:extLst>
          </p:cNvPr>
          <p:cNvSpPr txBox="1"/>
          <p:nvPr/>
        </p:nvSpPr>
        <p:spPr>
          <a:xfrm>
            <a:off x="2386602" y="5287362"/>
            <a:ext cx="17625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idity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2D338A4-FC81-B263-062F-EDA40ADD857D}"/>
              </a:ext>
            </a:extLst>
          </p:cNvPr>
          <p:cNvSpPr txBox="1"/>
          <p:nvPr/>
        </p:nvSpPr>
        <p:spPr>
          <a:xfrm>
            <a:off x="4353533" y="5287362"/>
            <a:ext cx="18202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ractal dimension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63D08E3-925A-9AAD-246A-B8CB7D1E4748}"/>
              </a:ext>
            </a:extLst>
          </p:cNvPr>
          <p:cNvSpPr txBox="1"/>
          <p:nvPr/>
        </p:nvSpPr>
        <p:spPr>
          <a:xfrm>
            <a:off x="0" y="95860"/>
            <a:ext cx="61647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igure S2 Relationship between thresholds and sensitivity or specificity in ROC analysis for ages over 55y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BD8BAF4A-5862-A0F0-961C-17EDF2EDA0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694" y="561309"/>
            <a:ext cx="2088000" cy="208800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FACF2AD7-2E9E-C584-2AC3-DE989AB3CE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07653" y="561309"/>
            <a:ext cx="2088000" cy="208800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599B68BE-307A-F634-051A-1203FF33E0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66943" y="561309"/>
            <a:ext cx="2088000" cy="2088000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9813FFEA-0B8B-BF49-C219-2E829BDD772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694" y="3015578"/>
            <a:ext cx="2088000" cy="2088000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577FC8CD-9B46-6621-2D56-537D5CE6A71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07653" y="3015578"/>
            <a:ext cx="2088000" cy="2088000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653B506E-8DB1-4581-56CE-98A2CF41D00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66943" y="3015578"/>
            <a:ext cx="2088000" cy="2088000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FDE13874-B69A-843B-73CD-CDE3DCC77AF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8694" y="5363256"/>
            <a:ext cx="2088000" cy="2088000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53E8710D-0834-CDF1-0FA9-9A34CBD09F4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07653" y="5363256"/>
            <a:ext cx="2088000" cy="2088000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3C61F858-D4F6-CA25-8075-21FE9F952EA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66943" y="5363256"/>
            <a:ext cx="2088000" cy="208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8812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ctr">
          <a:defRPr kumimoji="1" sz="1000" dirty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277</TotalTime>
  <Words>115</Words>
  <Application>Microsoft Macintosh PowerPoint</Application>
  <PresentationFormat>ユーザー設定</PresentationFormat>
  <Paragraphs>43</Paragraphs>
  <Slides>3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Office テーマ</vt:lpstr>
      <vt:lpstr>Fractal dimension, circularity, and solidity of cell clusters in liquid-based endometrial cytology are potentially useful for endometrial cancer detection and prognosis prediction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numa Toshimichi</dc:creator>
  <cp:lastModifiedBy>Toshimichi Onuma</cp:lastModifiedBy>
  <cp:revision>16</cp:revision>
  <dcterms:created xsi:type="dcterms:W3CDTF">2023-04-20T00:26:34Z</dcterms:created>
  <dcterms:modified xsi:type="dcterms:W3CDTF">2024-06-23T01:12:58Z</dcterms:modified>
</cp:coreProperties>
</file>